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54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 showGuides="1">
      <p:cViewPr varScale="1">
        <p:scale>
          <a:sx n="80" d="100"/>
          <a:sy n="80" d="100"/>
        </p:scale>
        <p:origin x="3024" y="150"/>
      </p:cViewPr>
      <p:guideLst>
        <p:guide orient="horz" pos="4254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67FB7-0081-4E1C-B2FE-749205F2F6A6}" type="datetimeFigureOut">
              <a:rPr lang="ko-KR" altLang="en-US" smtClean="0"/>
              <a:t>2019-07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1BB2-4818-45DA-BB1B-31BF90F80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6097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67FB7-0081-4E1C-B2FE-749205F2F6A6}" type="datetimeFigureOut">
              <a:rPr lang="ko-KR" altLang="en-US" smtClean="0"/>
              <a:t>2019-07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1BB2-4818-45DA-BB1B-31BF90F80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2697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67FB7-0081-4E1C-B2FE-749205F2F6A6}" type="datetimeFigureOut">
              <a:rPr lang="ko-KR" altLang="en-US" smtClean="0"/>
              <a:t>2019-07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1BB2-4818-45DA-BB1B-31BF90F80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3827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67FB7-0081-4E1C-B2FE-749205F2F6A6}" type="datetimeFigureOut">
              <a:rPr lang="ko-KR" altLang="en-US" smtClean="0"/>
              <a:t>2019-07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1BB2-4818-45DA-BB1B-31BF90F80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237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67FB7-0081-4E1C-B2FE-749205F2F6A6}" type="datetimeFigureOut">
              <a:rPr lang="ko-KR" altLang="en-US" smtClean="0"/>
              <a:t>2019-07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1BB2-4818-45DA-BB1B-31BF90F80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8498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67FB7-0081-4E1C-B2FE-749205F2F6A6}" type="datetimeFigureOut">
              <a:rPr lang="ko-KR" altLang="en-US" smtClean="0"/>
              <a:t>2019-07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1BB2-4818-45DA-BB1B-31BF90F80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42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67FB7-0081-4E1C-B2FE-749205F2F6A6}" type="datetimeFigureOut">
              <a:rPr lang="ko-KR" altLang="en-US" smtClean="0"/>
              <a:t>2019-07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1BB2-4818-45DA-BB1B-31BF90F80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0876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67FB7-0081-4E1C-B2FE-749205F2F6A6}" type="datetimeFigureOut">
              <a:rPr lang="ko-KR" altLang="en-US" smtClean="0"/>
              <a:t>2019-07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1BB2-4818-45DA-BB1B-31BF90F80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2946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67FB7-0081-4E1C-B2FE-749205F2F6A6}" type="datetimeFigureOut">
              <a:rPr lang="ko-KR" altLang="en-US" smtClean="0"/>
              <a:t>2019-07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1BB2-4818-45DA-BB1B-31BF90F80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2828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67FB7-0081-4E1C-B2FE-749205F2F6A6}" type="datetimeFigureOut">
              <a:rPr lang="ko-KR" altLang="en-US" smtClean="0"/>
              <a:t>2019-07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1BB2-4818-45DA-BB1B-31BF90F80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4422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67FB7-0081-4E1C-B2FE-749205F2F6A6}" type="datetimeFigureOut">
              <a:rPr lang="ko-KR" altLang="en-US" smtClean="0"/>
              <a:t>2019-07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41BB2-4818-45DA-BB1B-31BF90F80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8334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667FB7-0081-4E1C-B2FE-749205F2F6A6}" type="datetimeFigureOut">
              <a:rPr lang="ko-KR" altLang="en-US" smtClean="0"/>
              <a:t>2019-07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41BB2-4818-45DA-BB1B-31BF90F805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4277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987866" y="457926"/>
            <a:ext cx="5411413" cy="9220648"/>
            <a:chOff x="987866" y="457926"/>
            <a:chExt cx="5411413" cy="9220648"/>
          </a:xfrm>
        </p:grpSpPr>
        <p:grpSp>
          <p:nvGrpSpPr>
            <p:cNvPr id="10" name="그룹 9"/>
            <p:cNvGrpSpPr/>
            <p:nvPr/>
          </p:nvGrpSpPr>
          <p:grpSpPr>
            <a:xfrm>
              <a:off x="1292758" y="765703"/>
              <a:ext cx="3011933" cy="893681"/>
              <a:chOff x="1260790" y="1050877"/>
              <a:chExt cx="3706995" cy="1099915"/>
            </a:xfrm>
          </p:grpSpPr>
          <p:grpSp>
            <p:nvGrpSpPr>
              <p:cNvPr id="8" name="그룹 7"/>
              <p:cNvGrpSpPr/>
              <p:nvPr/>
            </p:nvGrpSpPr>
            <p:grpSpPr>
              <a:xfrm>
                <a:off x="1260790" y="1050877"/>
                <a:ext cx="3706995" cy="1078608"/>
                <a:chOff x="1260790" y="1050877"/>
                <a:chExt cx="3706995" cy="1078608"/>
              </a:xfrm>
            </p:grpSpPr>
            <p:pic>
              <p:nvPicPr>
                <p:cNvPr id="3" name="그림 2"/>
                <p:cNvPicPr>
                  <a:picLocks noChangeAspect="1"/>
                </p:cNvPicPr>
                <p:nvPr/>
              </p:nvPicPr>
              <p:blipFill rotWithShape="1">
                <a:blip r:embed="rId2"/>
                <a:srcRect t="9630" r="16662" b="23026"/>
                <a:stretch/>
              </p:blipFill>
              <p:spPr>
                <a:xfrm>
                  <a:off x="1260790" y="1050877"/>
                  <a:ext cx="3706995" cy="962167"/>
                </a:xfrm>
                <a:prstGeom prst="rect">
                  <a:avLst/>
                </a:prstGeom>
              </p:spPr>
            </p:pic>
            <p:cxnSp>
              <p:nvCxnSpPr>
                <p:cNvPr id="7" name="직선 연결선 6"/>
                <p:cNvCxnSpPr/>
                <p:nvPr/>
              </p:nvCxnSpPr>
              <p:spPr>
                <a:xfrm>
                  <a:off x="3804814" y="2129485"/>
                  <a:ext cx="954000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" name="TextBox 8"/>
              <p:cNvSpPr txBox="1"/>
              <p:nvPr/>
            </p:nvSpPr>
            <p:spPr>
              <a:xfrm>
                <a:off x="3955441" y="1852486"/>
                <a:ext cx="694865" cy="298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75" dirty="0">
                    <a:latin typeface="Arial" panose="020B0604020202020204" pitchFamily="34" charset="0"/>
                    <a:cs typeface="Arial" panose="020B0604020202020204" pitchFamily="34" charset="0"/>
                  </a:rPr>
                  <a:t>100 aa</a:t>
                </a:r>
                <a:endParaRPr lang="ko-KR" altLang="en-US" sz="975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" name="그룹 4"/>
            <p:cNvGrpSpPr/>
            <p:nvPr/>
          </p:nvGrpSpPr>
          <p:grpSpPr>
            <a:xfrm>
              <a:off x="1292758" y="2613307"/>
              <a:ext cx="5106521" cy="7065267"/>
              <a:chOff x="1292758" y="2613307"/>
              <a:chExt cx="5106521" cy="7065267"/>
            </a:xfrm>
          </p:grpSpPr>
          <p:sp>
            <p:nvSpPr>
              <p:cNvPr id="6" name="직사각형 5"/>
              <p:cNvSpPr/>
              <p:nvPr/>
            </p:nvSpPr>
            <p:spPr>
              <a:xfrm>
                <a:off x="1292758" y="2613307"/>
                <a:ext cx="5106521" cy="706526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18g06110 	----MLKKKTLHPPILFRHHTPSTTPELSPTSSSSDSESDEDMDSSGSRPLSLTVPPGAF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O090003000066 	----MLKKKTLYPPLHFWHSTPTSTPELSPTSSSSDSESDEDMDLSGSRPLSLTVPAGAF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L2T_02880 	----MLKKKTLYPPLHFWHSTPTSTPELSPTSSSSDSESDEDMDLSGSRPLSLTVPAGAF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5755 	----MLKKKSSHPPLLFWHSSPTSTPELSPTSSSSDTESDEDMDASGSRPLSLAVPQGTF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CLA_088640 	----MLKKRSLYPPLFFWNNSPTSTPELSPTSSSSDSESDEDMESSGSRPLSLNA-PGAF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u6g06860 	MLYAMLKKRSLYPPLFFWNNSPTTTPELSPTSSSSDSESDEDMDSSGSRPLSLNVQPGSF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NFIA_052510 	----MLKKRSLYPPLFFWNNSPTTTPELSPTSSSSDSESDEDMDSSGSRPLSLNVQPGAF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	    ****.: :**: *.: :*::************:******: ******** .  *:* </a:t>
                </a:r>
              </a:p>
              <a:p>
                <a:endParaRPr lang="en-US" altLang="ko-KR" sz="731" dirty="0"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endParaRP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18g06110 	CPMRPSLDEVLANTAPAPYTLSAFMAYLSQNHCLETLEFTLEAKRYRETYDALSRQLNES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O090003000066 	CPMRPTLDEVLANTAPAPYTLSAFMAYLSQNHCLETLEFTLEAKRYRETYEALSQQLGEY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L2T_02880 	CPMRPTLDEVLANTAPAPYTLSAFMAYLSQNHCLETLEFTLEAKRYRETYEALSQQLGEY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5755 	CPMRPTLDEVLANTAPAPYTLGAFMAYLSQNHCLETLEFTLDAKRYRETYNELSRQLGQF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CLA_088640 	CPMRPTLDEVLANTAPAPYTLSAFMAYLSQNHCLETLEFTLEAKRYRETYDSLTHRLQES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u6g06860 	CPMRPTLDEVLANTAPAPYTLSAFMAYLSQNHCLETLEFTLEAKRYRETYHSLTHQLRES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NFIA_052510 	CPMRPTLDEVLANTAPAPYTLSAFMAYLSQNHCLETLEFTLEAKRYRETYHSLTHQLRES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	*****:***************.*******************:********  *:..* : </a:t>
                </a:r>
              </a:p>
              <a:p>
                <a:endParaRPr lang="en-US" altLang="ko-KR" sz="731" dirty="0"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endParaRP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18g06110 	PIVTDCTGSQHLRMLWQRLLTAYILPGSPREINVSSEVRDDILRHANLPNPPLPETLDAA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O090003000066 	PIGTECPESQHLRMLWQRLLTAYIMPGSPREINVSSEVRDDILRQANSTIPPLPETLDAA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L2T_02880 	PIGTECPESQHLRMLWQRLLTAYIMPGSPREINVSSEVRDDILRQANSTTPPLPETLDAA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5755 	PIEADCSESRHLRMLWQRLLSAYILPGSPREINVSSEVRDDILRHANSSIPPPPSMLDAA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CLA_088640 	PIVTDCPESQHLRMLWQRLLTAYVIAGAPREINVSSEVREEILRQANAHTPPPPETLDAA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u6g06860 	PIVTDCPESQHLRMLWQRLLTAYILPGAPREINVCSEVREEIVQHANSHIPPPPETLDAA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NFIA_052510 	PIVTDCPESQHLRMLWQRLLTAYVLPGAPREINVCSEVREEILQHANSHIPPPPETLDAA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	** ::*. *.**********:**::.*:******.****::*:.:**   ** *. **** </a:t>
                </a:r>
              </a:p>
              <a:p>
                <a:endParaRPr lang="en-US" altLang="ko-KR" sz="731" dirty="0"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endParaRP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18g06110 	VKLVHDLMEESIFLPFLNSHASTAHVLPLSEPLFPHED-DITVVSNSSFDEHTASRGRSK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O090003000066 	VKLVHELMEESIFLPFLNAHSASAQVVPLAEPLFPQED-GVMVVAGPGLDEHAMKRARSK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L2T_02880 	VKLVHELMEESIFLPFLNAHSASAQVVPLAEPLFPQED-GVTVVAGPGLDEHAMKRARSK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5755 	VKLVHDLMEESIFMPFLNAHSSSAHVYPLSEPLFSQDDGGVTIVSNPSLDEHAVKRVRSK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CLA_088640 	VKLVHDLMEESIFIPFLNAHASSAHVLPLSEPLFPNDE-DVTVVSHSNLDEHAVKRVRSK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u6g06860 	VKLVHDLMEESIFLPFLNAHATSAHVVPLSEPLFSNED-DVTVVSNPSFDEHAVKR----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NFIA_052510 	VKLVHDLMEESIFLPFLNAHATSAHVLPLSEPLFSNED-DVTVVSNPSLDEHVVKR----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	*****:*******:****:*:::*:* **:****.::: .: :*: ..:***. .* </a:t>
                </a:r>
              </a:p>
              <a:p>
                <a:endParaRPr lang="en-US" altLang="ko-KR" sz="731" dirty="0"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endParaRP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18g06110 	RRRQSPQSSKDLGSPVSVGSPPS---RSNFSLSAMTSMGKVGHRTLGQVSNA-SGDSASG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O090003000066 	GRRLSPRSSKDFGSPTYSSSHSG---RSNFSLSAMTSMGKSSHRHSSHTSSG-SGDCSAG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L2T_02880 	GRRLSPRSSKDFGSPTYSSSHSG---RSNFSLSAMTSMGKSSHRHSSHTSSG-SGDCSAG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5755 	GGRLSPRQSRELGSPISSSPPSSL-SRSNFSLNAVTSLGKSSHRSSNQPSSA-SGESGSA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CLA_088640 	GKRLSPKSSRELGSPISSGPPSGHSSRTNFSLNAVTSIGKSSNRSSGPTSST-SGESGSA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u6g06860 	GRRLSPKSSRELGAPVPSGPPSGHSSRSNFSFGAVTSMGKTSNRTSGQVSSATSGDCA–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NFIA_052510 	GRRLSPKSSRELGAPVSSGPPSGHSSRSNFSFGAVTSMGKTSNRTSGQVSSTTSGDSA–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	  * **..*.::*:*   .. ..   *:***:.*:**:** .:*  .  *.  **:.. </a:t>
                </a:r>
              </a:p>
              <a:p>
                <a:pPr marL="139303" indent="-139303">
                  <a:buFont typeface="Arial" panose="020B0604020202020204" pitchFamily="34" charset="0"/>
                  <a:buChar char="•"/>
                </a:pPr>
                <a:endParaRPr lang="en-US" altLang="ko-KR" sz="731" dirty="0"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endParaRP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18g06110 	ALTDDSGSLQSSASVGEPMTPPTTPPSSDPHCMHLAHSPK-RTDNPWKKMGLKLGFKKRS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O090003000066 	-LTDDSGSLQSM-STSEPMTPPTTPPSSDAHGLHLAHSPKQRTDNPWKKMGMKLGFKKRS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L2T_02880 	-LTDDSGSLQSM-STSEPMTPPTTPPSSDAHGLHLAHSPKQRTDNPWKKMGMKLGFKKRS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5755 	GLSDDSGSMQS--SAGEPMTPPTTPPSSEPS-MQTG-SPKNRMDNPWKKMGMKLGFKRR-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CLA_088640 	ALTDDSGSSQ---SAGEPMTPPTTPPSSEPY-MPLGHSPKHRTENPWKKMGMKLGFKKRS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u6g06860 	-LTDDSGSTQSNHSTGEPMTPPTTPPSSEPS-LTLGHSPKHRTENPWKKMGMKLGFKKRS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NFIA_052510 	-LTDDSGSTQSNHSTGEPMTPPTTPPSSEPS-LTLGHSPKHRTENPWKKMGMKFGFKKRS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	 *:***** *   *..************:.  :  . *** * :*******:*:***.* </a:t>
                </a:r>
              </a:p>
              <a:p>
                <a:endParaRPr lang="en-US" altLang="ko-KR" sz="731" dirty="0">
                  <a:latin typeface="MS Gothic" panose="020B0609070205080204" pitchFamily="49" charset="-128"/>
                  <a:ea typeface="MS Gothic" panose="020B0609070205080204" pitchFamily="49" charset="-128"/>
                  <a:cs typeface="Arial" panose="020B0604020202020204" pitchFamily="34" charset="0"/>
                </a:endParaRP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18g06110 	GHGGSGNQHFKLSGMDE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O090003000066 	TTGSSGSNKL--SGTDE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L2T_02880 	TTGSSGSNKL--SGTDE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N5755 	---GGGSQSMR-LPHEE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CLA_088640 	ANGSSGSQHMRFSSMDE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Afu6g06860 	GHGGSGSQNLR-SSMDD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NFIA_052510 	GHGGSSSQNLR-SSMDD </a:t>
                </a:r>
              </a:p>
              <a:p>
                <a:r>
                  <a:rPr lang="en-US" altLang="ko-KR" sz="731" dirty="0">
                    <a:latin typeface="MS Gothic" panose="020B0609070205080204" pitchFamily="49" charset="-128"/>
                    <a:ea typeface="MS Gothic" panose="020B0609070205080204" pitchFamily="49" charset="-128"/>
                    <a:cs typeface="Arial" panose="020B0604020202020204" pitchFamily="34" charset="0"/>
                  </a:rPr>
                  <a:t>	   ....: :     :: </a:t>
                </a:r>
                <a:endParaRPr lang="ko-KR" altLang="en-US" sz="731" dirty="0">
                  <a:latin typeface="MS Gothic" panose="020B0609070205080204" pitchFamily="49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4" name="직사각형 3"/>
              <p:cNvSpPr/>
              <p:nvPr/>
            </p:nvSpPr>
            <p:spPr>
              <a:xfrm>
                <a:off x="2520950" y="3663950"/>
                <a:ext cx="2552700" cy="800100"/>
              </a:xfrm>
              <a:prstGeom prst="rect">
                <a:avLst/>
              </a:prstGeom>
              <a:solidFill>
                <a:srgbClr val="FFFF00">
                  <a:alpha val="30000"/>
                </a:srgbClr>
              </a:solidFill>
              <a:ln w="6350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1" name="직사각형 10"/>
              <p:cNvSpPr/>
              <p:nvPr/>
            </p:nvSpPr>
            <p:spPr>
              <a:xfrm>
                <a:off x="2279650" y="4654234"/>
                <a:ext cx="2794000" cy="800100"/>
              </a:xfrm>
              <a:prstGeom prst="rect">
                <a:avLst/>
              </a:prstGeom>
              <a:solidFill>
                <a:srgbClr val="FFFF00">
                  <a:alpha val="30000"/>
                </a:srgbClr>
              </a:solidFill>
              <a:ln w="6350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2" name="직사각형 11"/>
              <p:cNvSpPr/>
              <p:nvPr/>
            </p:nvSpPr>
            <p:spPr>
              <a:xfrm>
                <a:off x="2279650" y="5657218"/>
                <a:ext cx="1213200" cy="800100"/>
              </a:xfrm>
              <a:prstGeom prst="rect">
                <a:avLst/>
              </a:prstGeom>
              <a:solidFill>
                <a:srgbClr val="FFFF00">
                  <a:alpha val="30000"/>
                </a:srgbClr>
              </a:solidFill>
              <a:ln w="6350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>
              <a:off x="987866" y="2292757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987866" y="457926"/>
              <a:ext cx="3048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08775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3</TotalTime>
  <Words>5</Words>
  <Application>Microsoft Office PowerPoint</Application>
  <PresentationFormat>A4 Paper (210x297 mm)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MS Gothic</vt:lpstr>
      <vt:lpstr>맑은 고딕</vt:lpstr>
      <vt:lpstr>Arial</vt:lpstr>
      <vt:lpstr>Calibri</vt:lpstr>
      <vt:lpstr>Calibri Light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hin</dc:creator>
  <cp:lastModifiedBy>Jae-Hyuk Yu</cp:lastModifiedBy>
  <cp:revision>21</cp:revision>
  <dcterms:created xsi:type="dcterms:W3CDTF">2019-01-16T04:01:42Z</dcterms:created>
  <dcterms:modified xsi:type="dcterms:W3CDTF">2019-07-26T15:39:26Z</dcterms:modified>
</cp:coreProperties>
</file>